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206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78"/>
    <p:restoredTop sz="96291"/>
  </p:normalViewPr>
  <p:slideViewPr>
    <p:cSldViewPr snapToGrid="0" snapToObjects="1" showGuides="1">
      <p:cViewPr varScale="1">
        <p:scale>
          <a:sx n="89" d="100"/>
          <a:sy n="89" d="100"/>
        </p:scale>
        <p:origin x="557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8C38180-5D31-F141-91FE-FB915BA692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8720748-E306-7C49-9F8A-69A753C4C6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8DDD21-DFE1-F647-9ED1-72A006057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2D5F499-03E6-1249-B336-D4820A1F7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98DE542-9039-0B44-A573-A611CCED8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2815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097AA2-8E43-E648-B77D-F317F261B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086E639-5731-584D-93B9-9A1943719E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AC1ECC4-33A7-944C-BB40-DD0B403BC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B9144D0-869E-C947-B909-AE7D01C86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605F870-92A9-7E4E-AD2F-BAAE63331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0051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C645D1B-5EAB-D046-B31D-15F5522206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73AA4BB-2399-C148-BE69-2CBE6FC132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62DC24-F715-5543-ACBB-33FCC5F24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70452E-2D39-5A4D-B116-2E9E0DEE8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8557C0A-3738-3944-AC5E-1F6E4AB5D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6856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36B5DD4-F31A-7148-98BC-4A6482EE70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31D6FB6-835F-3C47-B81E-94F6BA51A8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552EF0-1151-9942-9A26-989EB69C7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7CCBF78-9C63-664B-A48A-6317553E2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C77D2AB-20CE-A045-9A45-406EEC24E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4396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81BEDD4-DDC3-2841-9E02-3000B40B00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40045BE-50EC-B345-97D7-8447A1871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ED08AC4-AFF2-A64A-85B8-B60EAE8F7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06A3668-56FD-3140-B959-0826A28C7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8E6DEEE-C6D0-0C4E-BDD7-7231A130C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3806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3BFA555-C0BA-314F-9F3E-6E5BC6EA1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39A4528-E05E-6C47-BC7A-256DC9FD4C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E5F5BA8-9AD1-284E-A460-197709D885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D85AB71-BEAF-394A-BA2B-E56337CCF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69C8C3A-F3D0-8E41-A628-FDE4B5EB6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560D968-B0EE-C247-8F38-6C1661CAD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5231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F6A024-1C4C-E842-A620-09D8A3F24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11162D4-31E3-6141-8398-ED2C75407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B1F3400-AB50-B84B-9D0E-13313B144F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79C967A-8267-0F41-AB7D-3930414942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524E64C-97EA-1E48-9957-C91404D6FE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91DE32E-D7A3-8A44-91AD-EF1F4F66A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D22A44F-7093-F240-998D-1CD11E093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0B32395-890F-8544-BE63-918630E06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6135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752700-6FF0-124D-B4B9-7C86A6DD4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2AEE615-C4E3-0F44-9E3E-863A0DE23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F5CDCF4-E885-AB41-ACF9-FF532AEBD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84D7032-ED71-974C-9ED9-A4B38262A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9756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A42231B-4CE2-0A43-94C3-6767755D5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955D132-B7C5-6344-9D45-A4733723A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FF28A4A-B07F-EB49-A984-07CBE5C0C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2353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06830F2-0C40-3D45-B525-97258E363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D3B5C43-4B02-864B-8517-89751BC07C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CC7F0A9-B4E6-0F40-AC0D-7B2BC1378B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384A7B6-B94C-B241-AE46-36F2AD1F9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E7ACEDC-8E16-4945-B300-B03FB241A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540E365-A56D-764D-8246-E488E933B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9013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E9CE30-1F1F-6446-A269-B49874905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B1CDB56-0D94-5246-8350-80096836DF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BC85359-AB0C-0E4A-AACA-42C4D9C301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36C0598-E707-1F41-8448-0BE8158CD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FD87345-73B9-3744-86AC-35D45A78D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28FD14D-0BB7-1E42-BBD7-2BF4CE515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4120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58DCE8D-5FAA-C748-B7BC-B0D11F5EA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024310D-18CA-1548-B27D-A27F58F415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F805E9A-CFA4-B049-894E-94F226B97E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1D03235-8A25-764B-826A-88894D6B6C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B61A7E1-4297-9346-8690-3D0679217F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6147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7C78CB2F-5F2B-A841-A66B-804B86333D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6758559"/>
              </p:ext>
            </p:extLst>
          </p:nvPr>
        </p:nvGraphicFramePr>
        <p:xfrm>
          <a:off x="425450" y="114300"/>
          <a:ext cx="9882188" cy="5456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1" name="Documento" r:id="rId3" imgW="9144000" imgH="5067300" progId="Word.Document.12">
                  <p:embed/>
                </p:oleObj>
              </mc:Choice>
              <mc:Fallback>
                <p:oleObj name="Documento" r:id="rId3" imgW="9144000" imgH="50673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5450" y="114300"/>
                        <a:ext cx="9882188" cy="5456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ttangolo 4">
            <a:extLst>
              <a:ext uri="{FF2B5EF4-FFF2-40B4-BE49-F238E27FC236}">
                <a16:creationId xmlns:a16="http://schemas.microsoft.com/office/drawing/2014/main" id="{FD5EB159-6862-EC46-A48C-C4B07A130B90}"/>
              </a:ext>
            </a:extLst>
          </p:cNvPr>
          <p:cNvSpPr/>
          <p:nvPr/>
        </p:nvSpPr>
        <p:spPr>
          <a:xfrm>
            <a:off x="6419017" y="344766"/>
            <a:ext cx="351692" cy="651694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F33D64E8-C6D3-9349-9B66-C2F87AD3FE0D}"/>
              </a:ext>
            </a:extLst>
          </p:cNvPr>
          <p:cNvSpPr/>
          <p:nvPr/>
        </p:nvSpPr>
        <p:spPr>
          <a:xfrm>
            <a:off x="5829239" y="337665"/>
            <a:ext cx="2248524" cy="666960"/>
          </a:xfrm>
          <a:prstGeom prst="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Rettangolo 24">
            <a:extLst>
              <a:ext uri="{FF2B5EF4-FFF2-40B4-BE49-F238E27FC236}">
                <a16:creationId xmlns:a16="http://schemas.microsoft.com/office/drawing/2014/main" id="{9D1C94D8-CFBE-674F-9D05-06212FCA9BD2}"/>
              </a:ext>
            </a:extLst>
          </p:cNvPr>
          <p:cNvSpPr/>
          <p:nvPr/>
        </p:nvSpPr>
        <p:spPr>
          <a:xfrm>
            <a:off x="7532966" y="2207240"/>
            <a:ext cx="333054" cy="514266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Rettangolo 25">
            <a:extLst>
              <a:ext uri="{FF2B5EF4-FFF2-40B4-BE49-F238E27FC236}">
                <a16:creationId xmlns:a16="http://schemas.microsoft.com/office/drawing/2014/main" id="{1DB45434-9260-EA48-BCA3-7AC3D3A33A85}"/>
              </a:ext>
            </a:extLst>
          </p:cNvPr>
          <p:cNvSpPr/>
          <p:nvPr/>
        </p:nvSpPr>
        <p:spPr>
          <a:xfrm>
            <a:off x="4264806" y="3015556"/>
            <a:ext cx="5190736" cy="597943"/>
          </a:xfrm>
          <a:prstGeom prst="rect">
            <a:avLst/>
          </a:prstGeom>
          <a:noFill/>
          <a:ln w="1905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Rettangolo 28">
            <a:extLst>
              <a:ext uri="{FF2B5EF4-FFF2-40B4-BE49-F238E27FC236}">
                <a16:creationId xmlns:a16="http://schemas.microsoft.com/office/drawing/2014/main" id="{42E30A41-81CF-3648-9AB8-FF2EBA46BFC9}"/>
              </a:ext>
            </a:extLst>
          </p:cNvPr>
          <p:cNvSpPr/>
          <p:nvPr/>
        </p:nvSpPr>
        <p:spPr>
          <a:xfrm>
            <a:off x="7455002" y="3031217"/>
            <a:ext cx="808110" cy="566619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32" name="Rettangolo 31">
            <a:extLst>
              <a:ext uri="{FF2B5EF4-FFF2-40B4-BE49-F238E27FC236}">
                <a16:creationId xmlns:a16="http://schemas.microsoft.com/office/drawing/2014/main" id="{C087CDDC-A8AB-6648-BE81-436B2C9C9810}"/>
              </a:ext>
            </a:extLst>
          </p:cNvPr>
          <p:cNvSpPr/>
          <p:nvPr/>
        </p:nvSpPr>
        <p:spPr>
          <a:xfrm>
            <a:off x="8909656" y="424713"/>
            <a:ext cx="586078" cy="605375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35" name="Rettangolo 34">
            <a:extLst>
              <a:ext uri="{FF2B5EF4-FFF2-40B4-BE49-F238E27FC236}">
                <a16:creationId xmlns:a16="http://schemas.microsoft.com/office/drawing/2014/main" id="{B9D3C682-E176-684C-8353-A98118E4162C}"/>
              </a:ext>
            </a:extLst>
          </p:cNvPr>
          <p:cNvSpPr/>
          <p:nvPr/>
        </p:nvSpPr>
        <p:spPr>
          <a:xfrm>
            <a:off x="5482632" y="3913562"/>
            <a:ext cx="263865" cy="529460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6" name="Rettangolo 35">
            <a:extLst>
              <a:ext uri="{FF2B5EF4-FFF2-40B4-BE49-F238E27FC236}">
                <a16:creationId xmlns:a16="http://schemas.microsoft.com/office/drawing/2014/main" id="{85C4F529-2A66-CA42-98E7-3E256B95D377}"/>
              </a:ext>
            </a:extLst>
          </p:cNvPr>
          <p:cNvSpPr/>
          <p:nvPr/>
        </p:nvSpPr>
        <p:spPr>
          <a:xfrm>
            <a:off x="8267953" y="4820529"/>
            <a:ext cx="327155" cy="529460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09656" y="4635650"/>
            <a:ext cx="1407172" cy="899217"/>
          </a:xfrm>
          <a:prstGeom prst="rect">
            <a:avLst/>
          </a:prstGeom>
        </p:spPr>
      </p:pic>
      <p:sp>
        <p:nvSpPr>
          <p:cNvPr id="13" name="Rechteck 12"/>
          <p:cNvSpPr/>
          <p:nvPr/>
        </p:nvSpPr>
        <p:spPr>
          <a:xfrm>
            <a:off x="351692" y="6220534"/>
            <a:ext cx="1024010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>
                <a:latin typeface="Palatino Linotype" panose="02040502050505030304" pitchFamily="18" charset="0"/>
              </a:rPr>
              <a:t>Figure S2: </a:t>
            </a:r>
            <a:r>
              <a:rPr lang="en-GB" sz="900" dirty="0">
                <a:latin typeface="Palatino Linotype" panose="02040502050505030304" pitchFamily="18" charset="0"/>
              </a:rPr>
              <a:t>Alignment of vertebrate PIAS2 orthologues </a:t>
            </a:r>
            <a:r>
              <a:rPr lang="de-DE" sz="900" dirty="0" err="1">
                <a:latin typeface="Palatino Linotype" panose="02040502050505030304" pitchFamily="18" charset="0"/>
              </a:rPr>
              <a:t>from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rainbow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rout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human </a:t>
            </a:r>
            <a:r>
              <a:rPr lang="de-DE" sz="900" dirty="0" err="1">
                <a:latin typeface="Palatino Linotype" panose="02040502050505030304" pitchFamily="18" charset="0"/>
              </a:rPr>
              <a:t>a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indicated</a:t>
            </a:r>
            <a:r>
              <a:rPr lang="de-DE" sz="900" dirty="0">
                <a:latin typeface="Palatino Linotype" panose="02040502050505030304" pitchFamily="18" charset="0"/>
              </a:rPr>
              <a:t> on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left</a:t>
            </a:r>
            <a:r>
              <a:rPr lang="de-DE" sz="900" dirty="0">
                <a:latin typeface="Palatino Linotype" panose="02040502050505030304" pitchFamily="18" charset="0"/>
              </a:rPr>
              <a:t>. </a:t>
            </a:r>
            <a:r>
              <a:rPr lang="de-DE" sz="900" dirty="0" err="1">
                <a:latin typeface="Palatino Linotype" panose="02040502050505030304" pitchFamily="18" charset="0"/>
              </a:rPr>
              <a:t>Characteristic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domain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motif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r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frame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labelle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ccording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o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legend at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bottom</a:t>
            </a:r>
            <a:r>
              <a:rPr lang="de-DE" sz="900" dirty="0">
                <a:latin typeface="Palatino Linotype" panose="02040502050505030304" pitchFamily="18" charset="0"/>
              </a:rPr>
              <a:t>. Conserved aa residues are highlighted in different colours reflecting the degree of conservation. </a:t>
            </a:r>
          </a:p>
        </p:txBody>
      </p:sp>
    </p:spTree>
    <p:extLst>
      <p:ext uri="{BB962C8B-B14F-4D97-AF65-F5344CB8AC3E}">
        <p14:creationId xmlns:p14="http://schemas.microsoft.com/office/powerpoint/2010/main" val="33021812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i Office</vt:lpstr>
      <vt:lpstr>Documento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rosoft Office User</dc:creator>
  <cp:lastModifiedBy>MDPI-118</cp:lastModifiedBy>
  <cp:revision>25</cp:revision>
  <dcterms:created xsi:type="dcterms:W3CDTF">2020-05-11T09:56:46Z</dcterms:created>
  <dcterms:modified xsi:type="dcterms:W3CDTF">2021-11-25T16:56:01Z</dcterms:modified>
</cp:coreProperties>
</file>